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0"/>
  </p:notesMasterIdLst>
  <p:sldIdLst>
    <p:sldId id="287" r:id="rId2"/>
    <p:sldId id="280" r:id="rId3"/>
    <p:sldId id="301" r:id="rId4"/>
    <p:sldId id="273" r:id="rId5"/>
    <p:sldId id="260" r:id="rId6"/>
    <p:sldId id="300" r:id="rId7"/>
    <p:sldId id="299" r:id="rId8"/>
    <p:sldId id="286" r:id="rId9"/>
  </p:sldIdLst>
  <p:sldSz cx="6480175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i" initials="X" lastIdx="1" clrIdx="0">
    <p:extLst>
      <p:ext uri="{19B8F6BF-5375-455C-9EA6-DF929625EA0E}">
        <p15:presenceInfo xmlns:p15="http://schemas.microsoft.com/office/powerpoint/2012/main" userId="26000aeac33f001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65" autoAdjust="0"/>
    <p:restoredTop sz="95344" autoAdjust="0"/>
  </p:normalViewPr>
  <p:slideViewPr>
    <p:cSldViewPr snapToGrid="0">
      <p:cViewPr>
        <p:scale>
          <a:sx n="70" d="100"/>
          <a:sy n="70" d="100"/>
        </p:scale>
        <p:origin x="1160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7EA056-8584-481D-A65D-AC885BF35B37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66938" y="1143000"/>
            <a:ext cx="2524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FAD1F8-E423-482E-BECF-7D97490C7A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01425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296173"/>
            <a:ext cx="5508149" cy="2757347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159854"/>
            <a:ext cx="4860131" cy="1912175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7C536-7D42-4FA2-B5A4-4E3FDA7719B8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3B128-D118-43F6-906C-CD551684C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6584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7C536-7D42-4FA2-B5A4-4E3FDA7719B8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3B128-D118-43F6-906C-CD551684C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7068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21669"/>
            <a:ext cx="1397288" cy="671186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21669"/>
            <a:ext cx="4110861" cy="671186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7C536-7D42-4FA2-B5A4-4E3FDA7719B8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3B128-D118-43F6-906C-CD551684C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790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7C536-7D42-4FA2-B5A4-4E3FDA7719B8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3B128-D118-43F6-906C-CD551684C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053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974512"/>
            <a:ext cx="5589151" cy="3294515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5300194"/>
            <a:ext cx="5589151" cy="173250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7C536-7D42-4FA2-B5A4-4E3FDA7719B8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3B128-D118-43F6-906C-CD551684C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7101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108344"/>
            <a:ext cx="2754074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108344"/>
            <a:ext cx="2754074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7C536-7D42-4FA2-B5A4-4E3FDA7719B8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3B128-D118-43F6-906C-CD551684C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548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21671"/>
            <a:ext cx="5589151" cy="153084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941510"/>
            <a:ext cx="2741417" cy="95150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2893014"/>
            <a:ext cx="2741417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941510"/>
            <a:ext cx="2754918" cy="95150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893014"/>
            <a:ext cx="2754918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7C536-7D42-4FA2-B5A4-4E3FDA7719B8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3B128-D118-43F6-906C-CD551684C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7691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7C536-7D42-4FA2-B5A4-4E3FDA7719B8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3B128-D118-43F6-906C-CD551684C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2730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7C536-7D42-4FA2-B5A4-4E3FDA7719B8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3B128-D118-43F6-906C-CD551684C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1775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28002"/>
            <a:ext cx="2090025" cy="1848009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140341"/>
            <a:ext cx="3280589" cy="5628360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376011"/>
            <a:ext cx="2090025" cy="4401855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7C536-7D42-4FA2-B5A4-4E3FDA7719B8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3B128-D118-43F6-906C-CD551684C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6564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28002"/>
            <a:ext cx="2090025" cy="1848009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140341"/>
            <a:ext cx="3280589" cy="5628360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376011"/>
            <a:ext cx="2090025" cy="4401855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7C536-7D42-4FA2-B5A4-4E3FDA7719B8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43B128-D118-43F6-906C-CD551684C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1065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21671"/>
            <a:ext cx="5589151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108344"/>
            <a:ext cx="5589151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7340703"/>
            <a:ext cx="145803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27C536-7D42-4FA2-B5A4-4E3FDA7719B8}" type="datetimeFigureOut">
              <a:rPr lang="zh-CN" altLang="en-US" smtClean="0"/>
              <a:t>2024/1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7340703"/>
            <a:ext cx="218705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7340703"/>
            <a:ext cx="145803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43B128-D118-43F6-906C-CD551684C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6963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microsoft.com/office/2007/relationships/hdphoto" Target="../media/hdphoto5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2" Type="http://schemas.openxmlformats.org/officeDocument/2006/relationships/image" Target="../media/image1.Tif"/><Relationship Id="rId16" Type="http://schemas.openxmlformats.org/officeDocument/2006/relationships/image" Target="../media/image10.Ti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Tif"/><Relationship Id="rId5" Type="http://schemas.openxmlformats.org/officeDocument/2006/relationships/image" Target="../media/image3.png"/><Relationship Id="rId15" Type="http://schemas.openxmlformats.org/officeDocument/2006/relationships/image" Target="../media/image9.Tif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openxmlformats.org/officeDocument/2006/relationships/image" Target="../media/image8.Tif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7.wdp"/><Relationship Id="rId13" Type="http://schemas.openxmlformats.org/officeDocument/2006/relationships/image" Target="../media/image19.png"/><Relationship Id="rId3" Type="http://schemas.openxmlformats.org/officeDocument/2006/relationships/image" Target="../media/image12.Tif"/><Relationship Id="rId7" Type="http://schemas.openxmlformats.org/officeDocument/2006/relationships/image" Target="../media/image15.png"/><Relationship Id="rId12" Type="http://schemas.openxmlformats.org/officeDocument/2006/relationships/image" Target="../media/image18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"/><Relationship Id="rId11" Type="http://schemas.openxmlformats.org/officeDocument/2006/relationships/image" Target="../media/image17.Tif"/><Relationship Id="rId5" Type="http://schemas.microsoft.com/office/2007/relationships/hdphoto" Target="../media/hdphoto6.wdp"/><Relationship Id="rId15" Type="http://schemas.openxmlformats.org/officeDocument/2006/relationships/image" Target="../media/image20.Tif"/><Relationship Id="rId10" Type="http://schemas.microsoft.com/office/2007/relationships/hdphoto" Target="../media/hdphoto8.wdp"/><Relationship Id="rId4" Type="http://schemas.openxmlformats.org/officeDocument/2006/relationships/image" Target="../media/image13.png"/><Relationship Id="rId9" Type="http://schemas.openxmlformats.org/officeDocument/2006/relationships/image" Target="../media/image16.png"/><Relationship Id="rId14" Type="http://schemas.microsoft.com/office/2007/relationships/hdphoto" Target="../media/hdphoto9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microsoft.com/office/2007/relationships/hdphoto" Target="../media/hdphoto10.wdp"/><Relationship Id="rId7" Type="http://schemas.microsoft.com/office/2007/relationships/hdphoto" Target="../media/hdphoto12.wdp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microsoft.com/office/2007/relationships/hdphoto" Target="../media/hdphoto11.wdp"/><Relationship Id="rId4" Type="http://schemas.openxmlformats.org/officeDocument/2006/relationships/image" Target="../media/image22.png"/><Relationship Id="rId9" Type="http://schemas.microsoft.com/office/2007/relationships/hdphoto" Target="../media/hdphoto13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6.wdp"/><Relationship Id="rId3" Type="http://schemas.microsoft.com/office/2007/relationships/hdphoto" Target="../media/hdphoto14.wdp"/><Relationship Id="rId7" Type="http://schemas.openxmlformats.org/officeDocument/2006/relationships/image" Target="../media/image28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5.wdp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g"/><Relationship Id="rId2" Type="http://schemas.openxmlformats.org/officeDocument/2006/relationships/image" Target="../media/image29.jpg"/><Relationship Id="rId1" Type="http://schemas.openxmlformats.org/officeDocument/2006/relationships/slideLayout" Target="../slideLayouts/slideLayout7.xml"/><Relationship Id="rId6" Type="http://schemas.microsoft.com/office/2007/relationships/hdphoto" Target="../media/hdphoto17.wdp"/><Relationship Id="rId5" Type="http://schemas.openxmlformats.org/officeDocument/2006/relationships/image" Target="../media/image32.png"/><Relationship Id="rId4" Type="http://schemas.openxmlformats.org/officeDocument/2006/relationships/image" Target="../media/image31.ti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openxmlformats.org/officeDocument/2006/relationships/image" Target="../media/image40.Tif"/><Relationship Id="rId3" Type="http://schemas.microsoft.com/office/2007/relationships/hdphoto" Target="../media/hdphoto18.wdp"/><Relationship Id="rId7" Type="http://schemas.microsoft.com/office/2007/relationships/hdphoto" Target="../media/hdphoto20.wdp"/><Relationship Id="rId12" Type="http://schemas.openxmlformats.org/officeDocument/2006/relationships/image" Target="../media/image39.Tif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11" Type="http://schemas.openxmlformats.org/officeDocument/2006/relationships/image" Target="../media/image38.Tif"/><Relationship Id="rId5" Type="http://schemas.microsoft.com/office/2007/relationships/hdphoto" Target="../media/hdphoto19.wdp"/><Relationship Id="rId10" Type="http://schemas.openxmlformats.org/officeDocument/2006/relationships/image" Target="../media/image37.Tif"/><Relationship Id="rId4" Type="http://schemas.openxmlformats.org/officeDocument/2006/relationships/image" Target="../media/image34.png"/><Relationship Id="rId9" Type="http://schemas.microsoft.com/office/2007/relationships/hdphoto" Target="../media/hdphoto21.wdp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22.wdp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2.Ti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4" Type="http://schemas.microsoft.com/office/2007/relationships/hdphoto" Target="../media/hdphoto2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图片 85">
            <a:extLst>
              <a:ext uri="{FF2B5EF4-FFF2-40B4-BE49-F238E27FC236}">
                <a16:creationId xmlns:a16="http://schemas.microsoft.com/office/drawing/2014/main" id="{316BFF7C-251D-B2D1-18C4-86D7C6249E3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0" t="400" r="-96" b="-833"/>
          <a:stretch/>
        </p:blipFill>
        <p:spPr>
          <a:xfrm>
            <a:off x="157719" y="5884582"/>
            <a:ext cx="1673615" cy="11174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7" name="图片 86">
            <a:extLst>
              <a:ext uri="{FF2B5EF4-FFF2-40B4-BE49-F238E27FC236}">
                <a16:creationId xmlns:a16="http://schemas.microsoft.com/office/drawing/2014/main" id="{C00848A0-919C-75A9-E174-1F6AE659E38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3" t="634" r="-356" b="843"/>
          <a:stretch/>
        </p:blipFill>
        <p:spPr>
          <a:xfrm>
            <a:off x="160629" y="4299656"/>
            <a:ext cx="1673616" cy="10960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0" name="图片 89">
            <a:extLst>
              <a:ext uri="{FF2B5EF4-FFF2-40B4-BE49-F238E27FC236}">
                <a16:creationId xmlns:a16="http://schemas.microsoft.com/office/drawing/2014/main" id="{BE9572D7-88B4-B282-AFE0-A4FCA632EBD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5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9" t="-256" r="-180" b="-842"/>
          <a:stretch/>
        </p:blipFill>
        <p:spPr>
          <a:xfrm>
            <a:off x="171123" y="2938006"/>
            <a:ext cx="1663122" cy="11197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9" name="图片 88">
            <a:extLst>
              <a:ext uri="{FF2B5EF4-FFF2-40B4-BE49-F238E27FC236}">
                <a16:creationId xmlns:a16="http://schemas.microsoft.com/office/drawing/2014/main" id="{71681519-E8A4-3136-E907-58000788ED3D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0" t="-221" r="-1036" b="376"/>
          <a:stretch/>
        </p:blipFill>
        <p:spPr>
          <a:xfrm>
            <a:off x="171123" y="1724976"/>
            <a:ext cx="1663122" cy="10971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798C561D-AE01-3815-71AE-01579BC8356B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4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50" t="368" r="181" b="-221"/>
          <a:stretch/>
        </p:blipFill>
        <p:spPr>
          <a:xfrm>
            <a:off x="171122" y="261254"/>
            <a:ext cx="1663122" cy="13521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D47EB753-4A9F-B297-D298-0696AB80893F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57" t="-795" r="-221" b="1079"/>
          <a:stretch/>
        </p:blipFill>
        <p:spPr>
          <a:xfrm>
            <a:off x="2084450" y="305518"/>
            <a:ext cx="2162894" cy="1353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1218876B-B527-BA60-4AB4-B35B4614741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8" t="968" r="416" b="434"/>
          <a:stretch/>
        </p:blipFill>
        <p:spPr>
          <a:xfrm>
            <a:off x="2084450" y="1743160"/>
            <a:ext cx="2162894" cy="12944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70DD4505-CD0C-CCE9-C45B-5A213D4ADD0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98" t="-761" r="32" b="569"/>
          <a:stretch/>
        </p:blipFill>
        <p:spPr>
          <a:xfrm flipH="1">
            <a:off x="2197299" y="5874807"/>
            <a:ext cx="1884684" cy="14743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858925F6-2F59-D49F-AF43-25F93136A8D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77" t="-770" r="204" b="-452"/>
          <a:stretch/>
        </p:blipFill>
        <p:spPr>
          <a:xfrm>
            <a:off x="2058194" y="4299656"/>
            <a:ext cx="1904519" cy="14743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6" name="图片 75">
            <a:extLst>
              <a:ext uri="{FF2B5EF4-FFF2-40B4-BE49-F238E27FC236}">
                <a16:creationId xmlns:a16="http://schemas.microsoft.com/office/drawing/2014/main" id="{B3B9EBBD-3BF6-67D1-9007-F216D1D51F3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9" t="-768" r="123" b="-943"/>
          <a:stretch/>
        </p:blipFill>
        <p:spPr>
          <a:xfrm>
            <a:off x="2058194" y="3133426"/>
            <a:ext cx="2162894" cy="11197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7" name="文本框 76">
            <a:extLst>
              <a:ext uri="{FF2B5EF4-FFF2-40B4-BE49-F238E27FC236}">
                <a16:creationId xmlns:a16="http://schemas.microsoft.com/office/drawing/2014/main" id="{BC1CF703-2228-ADB2-20CA-E2CA0675C36B}"/>
              </a:ext>
            </a:extLst>
          </p:cNvPr>
          <p:cNvSpPr txBox="1"/>
          <p:nvPr/>
        </p:nvSpPr>
        <p:spPr>
          <a:xfrm>
            <a:off x="236557" y="5990411"/>
            <a:ext cx="4363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4BFCD180-B471-467E-E870-9DB107079C3C}"/>
              </a:ext>
            </a:extLst>
          </p:cNvPr>
          <p:cNvSpPr txBox="1"/>
          <p:nvPr/>
        </p:nvSpPr>
        <p:spPr>
          <a:xfrm>
            <a:off x="195385" y="3037571"/>
            <a:ext cx="4667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GSDME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8AD83038-8938-B670-131D-E3873C6C458B}"/>
              </a:ext>
            </a:extLst>
          </p:cNvPr>
          <p:cNvSpPr txBox="1"/>
          <p:nvPr/>
        </p:nvSpPr>
        <p:spPr>
          <a:xfrm>
            <a:off x="80769" y="4338704"/>
            <a:ext cx="59503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GSDME-NT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4C56BFD6-B4FB-639F-577D-3BF672ABFCE7}"/>
              </a:ext>
            </a:extLst>
          </p:cNvPr>
          <p:cNvSpPr txBox="1"/>
          <p:nvPr/>
        </p:nvSpPr>
        <p:spPr>
          <a:xfrm>
            <a:off x="104540" y="1768430"/>
            <a:ext cx="88998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leaved-Caspase 3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3CFCA25C-8027-6777-1DAE-B03187D0F2CC}"/>
              </a:ext>
            </a:extLst>
          </p:cNvPr>
          <p:cNvSpPr txBox="1"/>
          <p:nvPr/>
        </p:nvSpPr>
        <p:spPr>
          <a:xfrm>
            <a:off x="378287" y="219897"/>
            <a:ext cx="5677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FA032560-D392-F62D-734C-AB1C0053E622}"/>
              </a:ext>
            </a:extLst>
          </p:cNvPr>
          <p:cNvSpPr txBox="1"/>
          <p:nvPr/>
        </p:nvSpPr>
        <p:spPr>
          <a:xfrm>
            <a:off x="946070" y="35231"/>
            <a:ext cx="38315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A375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A977F9E3-6A39-260E-461A-63B2CCA30687}"/>
              </a:ext>
            </a:extLst>
          </p:cNvPr>
          <p:cNvSpPr txBox="1"/>
          <p:nvPr/>
        </p:nvSpPr>
        <p:spPr>
          <a:xfrm>
            <a:off x="2723902" y="21008"/>
            <a:ext cx="5506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SK-MEL-2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17B025EE-9F4B-A99E-878C-AC7AB05D2575}"/>
              </a:ext>
            </a:extLst>
          </p:cNvPr>
          <p:cNvSpPr txBox="1"/>
          <p:nvPr/>
        </p:nvSpPr>
        <p:spPr bwMode="auto">
          <a:xfrm>
            <a:off x="6251" y="-25158"/>
            <a:ext cx="295274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defTabSz="594030"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2D7C9696-7B12-A25D-FFE9-1FA1BB477B28}"/>
              </a:ext>
            </a:extLst>
          </p:cNvPr>
          <p:cNvSpPr txBox="1"/>
          <p:nvPr/>
        </p:nvSpPr>
        <p:spPr>
          <a:xfrm>
            <a:off x="5603012" y="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4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FD8A1BEA-6090-67B3-8E1B-DA6B5C494906}"/>
              </a:ext>
            </a:extLst>
          </p:cNvPr>
          <p:cNvSpPr/>
          <p:nvPr/>
        </p:nvSpPr>
        <p:spPr>
          <a:xfrm>
            <a:off x="662178" y="2388887"/>
            <a:ext cx="389911" cy="833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6DEA4BC3-FA15-E158-6D7D-D7CB449879E8}"/>
              </a:ext>
            </a:extLst>
          </p:cNvPr>
          <p:cNvSpPr/>
          <p:nvPr/>
        </p:nvSpPr>
        <p:spPr>
          <a:xfrm>
            <a:off x="751115" y="4971220"/>
            <a:ext cx="389911" cy="833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7D4C36AC-C0A5-3345-1EC9-28AE2E020BE0}"/>
              </a:ext>
            </a:extLst>
          </p:cNvPr>
          <p:cNvSpPr/>
          <p:nvPr/>
        </p:nvSpPr>
        <p:spPr>
          <a:xfrm>
            <a:off x="2531254" y="938623"/>
            <a:ext cx="634644" cy="2398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C77820D-7204-5AE9-55F2-F98F618B003D}"/>
              </a:ext>
            </a:extLst>
          </p:cNvPr>
          <p:cNvSpPr txBox="1"/>
          <p:nvPr/>
        </p:nvSpPr>
        <p:spPr>
          <a:xfrm>
            <a:off x="2113454" y="305518"/>
            <a:ext cx="5677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aspase 3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2A433DF6-E88F-51C4-C7BB-E2F803B79A0F}"/>
              </a:ext>
            </a:extLst>
          </p:cNvPr>
          <p:cNvSpPr/>
          <p:nvPr/>
        </p:nvSpPr>
        <p:spPr>
          <a:xfrm>
            <a:off x="2622745" y="2303013"/>
            <a:ext cx="634644" cy="2398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862B90E1-A6E3-4503-8526-0F82B5D34F83}"/>
              </a:ext>
            </a:extLst>
          </p:cNvPr>
          <p:cNvSpPr/>
          <p:nvPr/>
        </p:nvSpPr>
        <p:spPr>
          <a:xfrm>
            <a:off x="2681899" y="3610088"/>
            <a:ext cx="634644" cy="2398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DF1EEFCD-E1F6-204A-20C7-C7663FF3567E}"/>
              </a:ext>
            </a:extLst>
          </p:cNvPr>
          <p:cNvSpPr/>
          <p:nvPr/>
        </p:nvSpPr>
        <p:spPr>
          <a:xfrm>
            <a:off x="2504997" y="5137653"/>
            <a:ext cx="634644" cy="2398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F9610938-3593-B4F8-AEC5-92992F671E72}"/>
              </a:ext>
            </a:extLst>
          </p:cNvPr>
          <p:cNvSpPr/>
          <p:nvPr/>
        </p:nvSpPr>
        <p:spPr>
          <a:xfrm>
            <a:off x="2406580" y="6555074"/>
            <a:ext cx="634644" cy="2398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9387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图片 95">
            <a:extLst>
              <a:ext uri="{FF2B5EF4-FFF2-40B4-BE49-F238E27FC236}">
                <a16:creationId xmlns:a16="http://schemas.microsoft.com/office/drawing/2014/main" id="{BB1D571B-8C9A-92DC-9A8E-EF29CACC964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0" t="1666" r="-73" b="-5285"/>
          <a:stretch/>
        </p:blipFill>
        <p:spPr>
          <a:xfrm>
            <a:off x="358291" y="5967685"/>
            <a:ext cx="2680310" cy="15019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7" name="图片 96">
            <a:extLst>
              <a:ext uri="{FF2B5EF4-FFF2-40B4-BE49-F238E27FC236}">
                <a16:creationId xmlns:a16="http://schemas.microsoft.com/office/drawing/2014/main" id="{E9960A16-0F5C-362F-C6C2-75E3CC55E8E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6" t="-472" r="-1315" b="1645"/>
          <a:stretch/>
        </p:blipFill>
        <p:spPr>
          <a:xfrm>
            <a:off x="393296" y="145831"/>
            <a:ext cx="2570603" cy="9023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8" name="图片 97">
            <a:extLst>
              <a:ext uri="{FF2B5EF4-FFF2-40B4-BE49-F238E27FC236}">
                <a16:creationId xmlns:a16="http://schemas.microsoft.com/office/drawing/2014/main" id="{5C58F515-8CC0-1876-17A6-92EA3925497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93" t="1290" r="187" b="105"/>
          <a:stretch/>
        </p:blipFill>
        <p:spPr>
          <a:xfrm>
            <a:off x="306289" y="1369273"/>
            <a:ext cx="2657610" cy="14176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9" name="图片 98">
            <a:extLst>
              <a:ext uri="{FF2B5EF4-FFF2-40B4-BE49-F238E27FC236}">
                <a16:creationId xmlns:a16="http://schemas.microsoft.com/office/drawing/2014/main" id="{1BC97F76-5A19-4B1F-55D1-1F261DDB27E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1" t="-1461" r="143" b="1383"/>
          <a:stretch/>
        </p:blipFill>
        <p:spPr>
          <a:xfrm>
            <a:off x="299526" y="2960092"/>
            <a:ext cx="2657610" cy="15136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0" name="图片 99">
            <a:extLst>
              <a:ext uri="{FF2B5EF4-FFF2-40B4-BE49-F238E27FC236}">
                <a16:creationId xmlns:a16="http://schemas.microsoft.com/office/drawing/2014/main" id="{FB341260-9CBF-ABF4-A411-F5159D3B752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-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0" t="664" r="125" b="1749"/>
          <a:stretch/>
        </p:blipFill>
        <p:spPr>
          <a:xfrm>
            <a:off x="302640" y="4646925"/>
            <a:ext cx="2735961" cy="10189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0401C571-03DE-FEDA-D3ED-D786F858ADAC}"/>
              </a:ext>
            </a:extLst>
          </p:cNvPr>
          <p:cNvSpPr txBox="1"/>
          <p:nvPr/>
        </p:nvSpPr>
        <p:spPr>
          <a:xfrm>
            <a:off x="291169" y="1413968"/>
            <a:ext cx="59503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GSDME-NT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3984DD0-BB67-9E46-DF0B-80DC34B4CE8C}"/>
              </a:ext>
            </a:extLst>
          </p:cNvPr>
          <p:cNvSpPr txBox="1"/>
          <p:nvPr/>
        </p:nvSpPr>
        <p:spPr>
          <a:xfrm>
            <a:off x="315213" y="3015657"/>
            <a:ext cx="54694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aspase3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AD683DF-FE08-ACEC-2077-22EF28282E0E}"/>
              </a:ext>
            </a:extLst>
          </p:cNvPr>
          <p:cNvSpPr txBox="1"/>
          <p:nvPr/>
        </p:nvSpPr>
        <p:spPr>
          <a:xfrm>
            <a:off x="264749" y="4664519"/>
            <a:ext cx="8691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leaved-Caspase3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6B10AAF-E633-0C83-EF50-DCFB0E7164AC}"/>
              </a:ext>
            </a:extLst>
          </p:cNvPr>
          <p:cNvSpPr txBox="1"/>
          <p:nvPr/>
        </p:nvSpPr>
        <p:spPr>
          <a:xfrm>
            <a:off x="562733" y="5984431"/>
            <a:ext cx="4363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DB261E9F-5C75-80E0-A9F2-B9A02D29B19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5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63" t="-1110" r="403" b="-1806"/>
          <a:stretch/>
        </p:blipFill>
        <p:spPr>
          <a:xfrm>
            <a:off x="3216211" y="132656"/>
            <a:ext cx="2134488" cy="11933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7" name="图片 76">
            <a:extLst>
              <a:ext uri="{FF2B5EF4-FFF2-40B4-BE49-F238E27FC236}">
                <a16:creationId xmlns:a16="http://schemas.microsoft.com/office/drawing/2014/main" id="{56ED5038-3ECE-40D8-F5E2-5511EEC831BD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" t="861" r="1856" b="3511"/>
          <a:stretch/>
        </p:blipFill>
        <p:spPr>
          <a:xfrm>
            <a:off x="3160313" y="1557350"/>
            <a:ext cx="2284478" cy="11933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8" name="图片 77">
            <a:extLst>
              <a:ext uri="{FF2B5EF4-FFF2-40B4-BE49-F238E27FC236}">
                <a16:creationId xmlns:a16="http://schemas.microsoft.com/office/drawing/2014/main" id="{37E13B3C-0A96-2428-E815-D7A05B0E063B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" t="129" r="-42" b="2123"/>
          <a:stretch/>
        </p:blipFill>
        <p:spPr>
          <a:xfrm>
            <a:off x="3216211" y="2982039"/>
            <a:ext cx="2228580" cy="11681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9" name="图片 78">
            <a:extLst>
              <a:ext uri="{FF2B5EF4-FFF2-40B4-BE49-F238E27FC236}">
                <a16:creationId xmlns:a16="http://schemas.microsoft.com/office/drawing/2014/main" id="{406217B3-7FEA-896E-339A-85C69BEBEBEC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40000" contras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42" t="-2431" r="1248" b="-1012"/>
          <a:stretch/>
        </p:blipFill>
        <p:spPr>
          <a:xfrm>
            <a:off x="3240087" y="4570517"/>
            <a:ext cx="3154260" cy="11488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id="{D1C0E654-D3A9-423A-B616-1F40C2D65707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8" t="2491" r="981" b="635"/>
          <a:stretch/>
        </p:blipFill>
        <p:spPr>
          <a:xfrm>
            <a:off x="3325916" y="5984431"/>
            <a:ext cx="2887159" cy="15647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1" name="文本框 100">
            <a:extLst>
              <a:ext uri="{FF2B5EF4-FFF2-40B4-BE49-F238E27FC236}">
                <a16:creationId xmlns:a16="http://schemas.microsoft.com/office/drawing/2014/main" id="{BBE0044A-03AF-E189-656D-B7194ECD0DE0}"/>
              </a:ext>
            </a:extLst>
          </p:cNvPr>
          <p:cNvSpPr txBox="1"/>
          <p:nvPr/>
        </p:nvSpPr>
        <p:spPr bwMode="auto">
          <a:xfrm>
            <a:off x="-16231" y="145831"/>
            <a:ext cx="304892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defTabSz="594030"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0F923E40-6940-556F-2E9D-2FA380E28181}"/>
              </a:ext>
            </a:extLst>
          </p:cNvPr>
          <p:cNvSpPr txBox="1"/>
          <p:nvPr/>
        </p:nvSpPr>
        <p:spPr>
          <a:xfrm>
            <a:off x="5603012" y="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5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D8123723-4291-BD12-9518-EB0C099B4073}"/>
              </a:ext>
            </a:extLst>
          </p:cNvPr>
          <p:cNvSpPr txBox="1"/>
          <p:nvPr/>
        </p:nvSpPr>
        <p:spPr>
          <a:xfrm>
            <a:off x="409108" y="195262"/>
            <a:ext cx="4667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GSDME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84079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图片 88">
            <a:extLst>
              <a:ext uri="{FF2B5EF4-FFF2-40B4-BE49-F238E27FC236}">
                <a16:creationId xmlns:a16="http://schemas.microsoft.com/office/drawing/2014/main" id="{78C25057-9EAA-F539-245C-35F8BF950D6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6" t="56" r="-521" b="-207"/>
          <a:stretch/>
        </p:blipFill>
        <p:spPr>
          <a:xfrm>
            <a:off x="619707" y="639375"/>
            <a:ext cx="1963381" cy="15991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0" name="图片 89">
            <a:extLst>
              <a:ext uri="{FF2B5EF4-FFF2-40B4-BE49-F238E27FC236}">
                <a16:creationId xmlns:a16="http://schemas.microsoft.com/office/drawing/2014/main" id="{990922C6-69F8-E1BE-F9FB-DB82BF723B5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5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99" t="1209" r="4404" b="-3229"/>
          <a:stretch/>
        </p:blipFill>
        <p:spPr>
          <a:xfrm>
            <a:off x="337970" y="2331475"/>
            <a:ext cx="2526854" cy="221525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8B17C17E-D608-3ED6-C62D-FD475D1F0504}"/>
              </a:ext>
            </a:extLst>
          </p:cNvPr>
          <p:cNvSpPr txBox="1"/>
          <p:nvPr/>
        </p:nvSpPr>
        <p:spPr>
          <a:xfrm>
            <a:off x="673747" y="688244"/>
            <a:ext cx="59503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GSDME-NT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B770FD8-CF63-326F-DEE2-8804D609A9CC}"/>
              </a:ext>
            </a:extLst>
          </p:cNvPr>
          <p:cNvSpPr txBox="1"/>
          <p:nvPr/>
        </p:nvSpPr>
        <p:spPr>
          <a:xfrm>
            <a:off x="811920" y="2376442"/>
            <a:ext cx="4267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FLOT1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4" name="图片 73">
            <a:extLst>
              <a:ext uri="{FF2B5EF4-FFF2-40B4-BE49-F238E27FC236}">
                <a16:creationId xmlns:a16="http://schemas.microsoft.com/office/drawing/2014/main" id="{F9175390-4481-9358-2EB7-C34EB859E27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3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18" t="1536" r="-5152" b="205"/>
          <a:stretch/>
        </p:blipFill>
        <p:spPr>
          <a:xfrm>
            <a:off x="3060479" y="2331475"/>
            <a:ext cx="2595695" cy="20031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0900D0B0-235C-64EF-C8FE-6DF8E1E7682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336" t="-847" r="-785" b="-539"/>
          <a:stretch/>
        </p:blipFill>
        <p:spPr>
          <a:xfrm>
            <a:off x="3060479" y="346822"/>
            <a:ext cx="2155805" cy="17289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1" name="文本框 110">
            <a:extLst>
              <a:ext uri="{FF2B5EF4-FFF2-40B4-BE49-F238E27FC236}">
                <a16:creationId xmlns:a16="http://schemas.microsoft.com/office/drawing/2014/main" id="{83B4EFA3-E9A9-800D-99EB-26B7ECCB826F}"/>
              </a:ext>
            </a:extLst>
          </p:cNvPr>
          <p:cNvSpPr txBox="1"/>
          <p:nvPr/>
        </p:nvSpPr>
        <p:spPr bwMode="auto">
          <a:xfrm>
            <a:off x="0" y="106470"/>
            <a:ext cx="295274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defTabSz="594030"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ACFE8F3-09FD-6AB9-585A-76064FE6D8B5}"/>
              </a:ext>
            </a:extLst>
          </p:cNvPr>
          <p:cNvSpPr txBox="1"/>
          <p:nvPr/>
        </p:nvSpPr>
        <p:spPr>
          <a:xfrm>
            <a:off x="5603012" y="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5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矩形 101">
            <a:extLst>
              <a:ext uri="{FF2B5EF4-FFF2-40B4-BE49-F238E27FC236}">
                <a16:creationId xmlns:a16="http://schemas.microsoft.com/office/drawing/2014/main" id="{132DAD3B-E38B-1FDB-D3BC-2CFF2153934B}"/>
              </a:ext>
            </a:extLst>
          </p:cNvPr>
          <p:cNvSpPr/>
          <p:nvPr/>
        </p:nvSpPr>
        <p:spPr>
          <a:xfrm>
            <a:off x="840669" y="1149690"/>
            <a:ext cx="1334027" cy="6124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3" name="矩形 102">
            <a:extLst>
              <a:ext uri="{FF2B5EF4-FFF2-40B4-BE49-F238E27FC236}">
                <a16:creationId xmlns:a16="http://schemas.microsoft.com/office/drawing/2014/main" id="{7A88EBA2-467F-2B9A-A2E3-E12620BB1C40}"/>
              </a:ext>
            </a:extLst>
          </p:cNvPr>
          <p:cNvSpPr/>
          <p:nvPr/>
        </p:nvSpPr>
        <p:spPr>
          <a:xfrm>
            <a:off x="3107430" y="1861896"/>
            <a:ext cx="1949020" cy="1243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27062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图片 29">
            <a:extLst>
              <a:ext uri="{FF2B5EF4-FFF2-40B4-BE49-F238E27FC236}">
                <a16:creationId xmlns:a16="http://schemas.microsoft.com/office/drawing/2014/main" id="{5C25BA52-5558-10EF-3E91-1F87CF116E2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26" t="2014" r="1874" b="769"/>
          <a:stretch/>
        </p:blipFill>
        <p:spPr>
          <a:xfrm>
            <a:off x="859219" y="3270112"/>
            <a:ext cx="1650214" cy="13315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A7FFACCF-8250-E274-1651-65875470141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25" t="13407" r="5153" b="2128"/>
          <a:stretch/>
        </p:blipFill>
        <p:spPr>
          <a:xfrm>
            <a:off x="859220" y="1900458"/>
            <a:ext cx="1633232" cy="12595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48B93FDE-77A8-8444-866A-A6AC883C23C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0000" contrast="-4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62" t="5681" r="1417" b="-727"/>
          <a:stretch/>
        </p:blipFill>
        <p:spPr>
          <a:xfrm>
            <a:off x="842239" y="4860641"/>
            <a:ext cx="1650214" cy="12931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DC562BA7-4F9A-A386-C837-F22AC9E8AB26}"/>
              </a:ext>
            </a:extLst>
          </p:cNvPr>
          <p:cNvSpPr txBox="1"/>
          <p:nvPr/>
        </p:nvSpPr>
        <p:spPr>
          <a:xfrm>
            <a:off x="859219" y="2010540"/>
            <a:ext cx="4667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GSDME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F15FF42-56B6-866D-0A29-63274FC84EDD}"/>
              </a:ext>
            </a:extLst>
          </p:cNvPr>
          <p:cNvSpPr txBox="1"/>
          <p:nvPr/>
        </p:nvSpPr>
        <p:spPr>
          <a:xfrm>
            <a:off x="993549" y="3399451"/>
            <a:ext cx="59503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GSDME-NT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C6DFA7C0-CADA-3B01-8096-39CCB91F66E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40" t="7463" r="904" b="-577"/>
          <a:stretch/>
        </p:blipFill>
        <p:spPr>
          <a:xfrm>
            <a:off x="859219" y="425087"/>
            <a:ext cx="1613340" cy="12595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6EBE273E-61BF-6A7C-70A8-E4EFA98076BB}"/>
              </a:ext>
            </a:extLst>
          </p:cNvPr>
          <p:cNvSpPr txBox="1"/>
          <p:nvPr/>
        </p:nvSpPr>
        <p:spPr bwMode="auto">
          <a:xfrm>
            <a:off x="168466" y="148088"/>
            <a:ext cx="295274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defTabSz="594030"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443DFD9-54BF-18E4-DF3D-74639E33C852}"/>
              </a:ext>
            </a:extLst>
          </p:cNvPr>
          <p:cNvSpPr txBox="1"/>
          <p:nvPr/>
        </p:nvSpPr>
        <p:spPr>
          <a:xfrm>
            <a:off x="5603012" y="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7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C2956C2B-85D2-1C94-62EF-13A152661446}"/>
              </a:ext>
            </a:extLst>
          </p:cNvPr>
          <p:cNvSpPr/>
          <p:nvPr/>
        </p:nvSpPr>
        <p:spPr>
          <a:xfrm>
            <a:off x="1291067" y="2477605"/>
            <a:ext cx="1119073" cy="1232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F5B95C8-1873-0A8A-C46D-9077F9D7F176}"/>
              </a:ext>
            </a:extLst>
          </p:cNvPr>
          <p:cNvSpPr txBox="1"/>
          <p:nvPr/>
        </p:nvSpPr>
        <p:spPr>
          <a:xfrm>
            <a:off x="920453" y="478134"/>
            <a:ext cx="8258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leved-Caspase3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F377BAD8-FB5F-2602-97EF-AE4470884A1B}"/>
              </a:ext>
            </a:extLst>
          </p:cNvPr>
          <p:cNvSpPr/>
          <p:nvPr/>
        </p:nvSpPr>
        <p:spPr>
          <a:xfrm>
            <a:off x="1291067" y="4064880"/>
            <a:ext cx="1119073" cy="771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07D91A71-A23F-907B-1CC9-D3655CC7E30C}"/>
              </a:ext>
            </a:extLst>
          </p:cNvPr>
          <p:cNvSpPr txBox="1"/>
          <p:nvPr/>
        </p:nvSpPr>
        <p:spPr>
          <a:xfrm>
            <a:off x="1065364" y="5002690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58991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文本框 22">
            <a:extLst>
              <a:ext uri="{FF2B5EF4-FFF2-40B4-BE49-F238E27FC236}">
                <a16:creationId xmlns:a16="http://schemas.microsoft.com/office/drawing/2014/main" id="{8129EB51-4D48-2933-4B8A-B3F3F300EE4B}"/>
              </a:ext>
            </a:extLst>
          </p:cNvPr>
          <p:cNvSpPr txBox="1"/>
          <p:nvPr/>
        </p:nvSpPr>
        <p:spPr>
          <a:xfrm>
            <a:off x="5603012" y="0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S1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图片 86">
            <a:extLst>
              <a:ext uri="{FF2B5EF4-FFF2-40B4-BE49-F238E27FC236}">
                <a16:creationId xmlns:a16="http://schemas.microsoft.com/office/drawing/2014/main" id="{13453544-169B-AB38-4BD0-251671554F5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" t="-1247" r="160" b="1012"/>
          <a:stretch/>
        </p:blipFill>
        <p:spPr>
          <a:xfrm>
            <a:off x="438951" y="2058351"/>
            <a:ext cx="1911075" cy="13586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AB1EF285-3F96-D137-7C46-027C26D0E4B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02" t="-1797" r="339" b="-1403"/>
          <a:stretch/>
        </p:blipFill>
        <p:spPr>
          <a:xfrm>
            <a:off x="438951" y="410993"/>
            <a:ext cx="1911075" cy="139003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89" name="文本框 88">
            <a:extLst>
              <a:ext uri="{FF2B5EF4-FFF2-40B4-BE49-F238E27FC236}">
                <a16:creationId xmlns:a16="http://schemas.microsoft.com/office/drawing/2014/main" id="{88B58888-234F-198A-03D4-53BFA23A6553}"/>
              </a:ext>
            </a:extLst>
          </p:cNvPr>
          <p:cNvSpPr txBox="1"/>
          <p:nvPr/>
        </p:nvSpPr>
        <p:spPr>
          <a:xfrm>
            <a:off x="311072" y="2080677"/>
            <a:ext cx="490032" cy="1722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520" b="1" dirty="0">
                <a:latin typeface="Arial" panose="020B0604020202020204" pitchFamily="34" charset="0"/>
                <a:cs typeface="Arial" panose="020B0604020202020204" pitchFamily="34" charset="0"/>
              </a:rPr>
              <a:t>GADPH</a:t>
            </a:r>
            <a:endParaRPr lang="zh-CN" altLang="en-US" sz="52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3CEDCEE5-997C-6B5E-0228-0207790A0F76}"/>
              </a:ext>
            </a:extLst>
          </p:cNvPr>
          <p:cNvSpPr txBox="1"/>
          <p:nvPr/>
        </p:nvSpPr>
        <p:spPr>
          <a:xfrm>
            <a:off x="405510" y="410993"/>
            <a:ext cx="428008" cy="1722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520" b="1" dirty="0">
                <a:latin typeface="Arial" panose="020B0604020202020204" pitchFamily="34" charset="0"/>
                <a:cs typeface="Arial" panose="020B0604020202020204" pitchFamily="34" charset="0"/>
              </a:rPr>
              <a:t>ACSL4</a:t>
            </a:r>
            <a:endParaRPr lang="zh-CN" altLang="en-US" sz="52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图片 44">
            <a:extLst>
              <a:ext uri="{FF2B5EF4-FFF2-40B4-BE49-F238E27FC236}">
                <a16:creationId xmlns:a16="http://schemas.microsoft.com/office/drawing/2014/main" id="{7743211F-BF76-C1AC-F9B9-9CDFE2B190E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" t="-1000" r="-618" b="912"/>
          <a:stretch/>
        </p:blipFill>
        <p:spPr>
          <a:xfrm>
            <a:off x="3332837" y="2260355"/>
            <a:ext cx="2270176" cy="18124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id="{2D5102F3-0016-01BD-0112-EF8D613D6DA6}"/>
              </a:ext>
            </a:extLst>
          </p:cNvPr>
          <p:cNvSpPr txBox="1"/>
          <p:nvPr/>
        </p:nvSpPr>
        <p:spPr>
          <a:xfrm>
            <a:off x="3353378" y="2286081"/>
            <a:ext cx="424321" cy="1723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520" b="1" dirty="0">
                <a:latin typeface="Arial" panose="020B0604020202020204" pitchFamily="34" charset="0"/>
                <a:cs typeface="Arial" panose="020B0604020202020204" pitchFamily="34" charset="0"/>
              </a:rPr>
              <a:t>GADPH</a:t>
            </a:r>
            <a:endParaRPr lang="zh-CN" altLang="en-US" sz="52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id="{30BBF711-98E0-A18B-8B1C-350D9EA66BD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0000" contrast="-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5" t="-134" r="-318" b="419"/>
          <a:stretch/>
        </p:blipFill>
        <p:spPr>
          <a:xfrm flipH="1">
            <a:off x="3332836" y="354319"/>
            <a:ext cx="2270176" cy="181247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id="{F665799E-D9F3-CD28-E024-A73D1238588F}"/>
              </a:ext>
            </a:extLst>
          </p:cNvPr>
          <p:cNvSpPr txBox="1"/>
          <p:nvPr/>
        </p:nvSpPr>
        <p:spPr>
          <a:xfrm>
            <a:off x="-16069" y="0"/>
            <a:ext cx="2792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2667A460-3245-E47D-F6BC-EC94D3BFDEB1}"/>
              </a:ext>
            </a:extLst>
          </p:cNvPr>
          <p:cNvSpPr txBox="1"/>
          <p:nvPr/>
        </p:nvSpPr>
        <p:spPr>
          <a:xfrm>
            <a:off x="3240087" y="0"/>
            <a:ext cx="3048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EDA5F6CD-1E09-55B8-4273-9F05C83755FF}"/>
              </a:ext>
            </a:extLst>
          </p:cNvPr>
          <p:cNvSpPr txBox="1"/>
          <p:nvPr/>
        </p:nvSpPr>
        <p:spPr>
          <a:xfrm>
            <a:off x="3240087" y="410865"/>
            <a:ext cx="460179" cy="1723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520" b="1" dirty="0">
                <a:latin typeface="Arial" panose="020B0604020202020204" pitchFamily="34" charset="0"/>
                <a:cs typeface="Arial" panose="020B0604020202020204" pitchFamily="34" charset="0"/>
              </a:rPr>
              <a:t>ACSL4</a:t>
            </a:r>
            <a:endParaRPr lang="zh-CN" altLang="en-US" sz="52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56668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文本框 48">
            <a:extLst>
              <a:ext uri="{FF2B5EF4-FFF2-40B4-BE49-F238E27FC236}">
                <a16:creationId xmlns:a16="http://schemas.microsoft.com/office/drawing/2014/main" id="{5480B5F9-75DD-199F-476D-41F1D0CAF32B}"/>
              </a:ext>
            </a:extLst>
          </p:cNvPr>
          <p:cNvSpPr txBox="1"/>
          <p:nvPr/>
        </p:nvSpPr>
        <p:spPr>
          <a:xfrm>
            <a:off x="4896915" y="30222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B16F1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9" name="图片 58">
            <a:extLst>
              <a:ext uri="{FF2B5EF4-FFF2-40B4-BE49-F238E27FC236}">
                <a16:creationId xmlns:a16="http://schemas.microsoft.com/office/drawing/2014/main" id="{10121855-A4C4-70E6-F946-048B36FA994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09" t="2269" r="6530" b="6143"/>
          <a:stretch/>
        </p:blipFill>
        <p:spPr>
          <a:xfrm>
            <a:off x="4080192" y="258326"/>
            <a:ext cx="2042050" cy="12495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7E130E82-18B6-35E5-CF32-D6CFF00EFB7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90" t="26291" r="715" b="27069"/>
          <a:stretch/>
        </p:blipFill>
        <p:spPr>
          <a:xfrm>
            <a:off x="4110904" y="6534409"/>
            <a:ext cx="2042050" cy="10775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BD827C6D-B620-307C-CD9A-1FCF06DD7E7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0000" contrast="-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62" t="3806" r="1695" b="4108"/>
          <a:stretch/>
        </p:blipFill>
        <p:spPr>
          <a:xfrm>
            <a:off x="4090593" y="1612594"/>
            <a:ext cx="2031649" cy="14593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E8E7A15C-4F54-1D1F-558C-574509B7438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584" t="3542" r="6059" b="2448"/>
          <a:stretch/>
        </p:blipFill>
        <p:spPr>
          <a:xfrm>
            <a:off x="4088216" y="5021860"/>
            <a:ext cx="2029237" cy="13467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DE49E16A-4E79-1B22-6DEE-C70E4AD84CA4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3" t="6366" r="79" b="1840"/>
          <a:stretch/>
        </p:blipFill>
        <p:spPr>
          <a:xfrm>
            <a:off x="4075403" y="3263778"/>
            <a:ext cx="2042050" cy="15799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4" name="文本框 53">
            <a:extLst>
              <a:ext uri="{FF2B5EF4-FFF2-40B4-BE49-F238E27FC236}">
                <a16:creationId xmlns:a16="http://schemas.microsoft.com/office/drawing/2014/main" id="{54BC2FF1-EA95-BF50-13B2-2DECCF0D3C2D}"/>
              </a:ext>
            </a:extLst>
          </p:cNvPr>
          <p:cNvSpPr txBox="1"/>
          <p:nvPr/>
        </p:nvSpPr>
        <p:spPr>
          <a:xfrm>
            <a:off x="4180127" y="6622972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775C97B4-FCDE-64FA-0AE3-F71EB2AE03A9}"/>
              </a:ext>
            </a:extLst>
          </p:cNvPr>
          <p:cNvSpPr txBox="1"/>
          <p:nvPr/>
        </p:nvSpPr>
        <p:spPr>
          <a:xfrm>
            <a:off x="4116016" y="3329892"/>
            <a:ext cx="5613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GSDME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BA9C0FA6-415C-9C6F-1557-733C9F3C8B96}"/>
              </a:ext>
            </a:extLst>
          </p:cNvPr>
          <p:cNvSpPr txBox="1"/>
          <p:nvPr/>
        </p:nvSpPr>
        <p:spPr>
          <a:xfrm>
            <a:off x="4011282" y="5109002"/>
            <a:ext cx="7312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GSDME-NT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1537F782-B554-5925-55E5-EAAC0A924630}"/>
              </a:ext>
            </a:extLst>
          </p:cNvPr>
          <p:cNvSpPr txBox="1"/>
          <p:nvPr/>
        </p:nvSpPr>
        <p:spPr>
          <a:xfrm>
            <a:off x="4180127" y="1620404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aspase3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87023991-BA12-0308-AE55-56A991A394CA}"/>
              </a:ext>
            </a:extLst>
          </p:cNvPr>
          <p:cNvSpPr txBox="1"/>
          <p:nvPr/>
        </p:nvSpPr>
        <p:spPr>
          <a:xfrm>
            <a:off x="4075402" y="64794"/>
            <a:ext cx="6671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aspase3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图片 76">
            <a:extLst>
              <a:ext uri="{FF2B5EF4-FFF2-40B4-BE49-F238E27FC236}">
                <a16:creationId xmlns:a16="http://schemas.microsoft.com/office/drawing/2014/main" id="{A643859A-1A35-BC06-C012-79C7A550F8F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3" t="51423" r="2274" b="2518"/>
          <a:stretch/>
        </p:blipFill>
        <p:spPr>
          <a:xfrm>
            <a:off x="1301960" y="5079649"/>
            <a:ext cx="2557217" cy="13031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8" name="图片 77">
            <a:extLst>
              <a:ext uri="{FF2B5EF4-FFF2-40B4-BE49-F238E27FC236}">
                <a16:creationId xmlns:a16="http://schemas.microsoft.com/office/drawing/2014/main" id="{4551CD51-46C5-FE1B-1774-4B8FFF94A0A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8" t="9044" r="2204" b="8504"/>
          <a:stretch/>
        </p:blipFill>
        <p:spPr>
          <a:xfrm>
            <a:off x="1548277" y="6655858"/>
            <a:ext cx="2222193" cy="10522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2" name="图片 81">
            <a:extLst>
              <a:ext uri="{FF2B5EF4-FFF2-40B4-BE49-F238E27FC236}">
                <a16:creationId xmlns:a16="http://schemas.microsoft.com/office/drawing/2014/main" id="{3241E240-2F07-5FA2-5C12-34C75673607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18" t="18726" r="4270" b="13011"/>
          <a:stretch/>
        </p:blipFill>
        <p:spPr>
          <a:xfrm>
            <a:off x="1385651" y="3275541"/>
            <a:ext cx="2473526" cy="15799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2" name="文本框 71">
            <a:extLst>
              <a:ext uri="{FF2B5EF4-FFF2-40B4-BE49-F238E27FC236}">
                <a16:creationId xmlns:a16="http://schemas.microsoft.com/office/drawing/2014/main" id="{935EC82F-9EDE-2D27-D7D4-B1B43B1DD568}"/>
              </a:ext>
            </a:extLst>
          </p:cNvPr>
          <p:cNvSpPr txBox="1"/>
          <p:nvPr/>
        </p:nvSpPr>
        <p:spPr>
          <a:xfrm>
            <a:off x="1539931" y="3473635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GSDME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FBB8D9F4-6512-AB69-85A1-74EDFEF4DD97}"/>
              </a:ext>
            </a:extLst>
          </p:cNvPr>
          <p:cNvSpPr txBox="1"/>
          <p:nvPr/>
        </p:nvSpPr>
        <p:spPr>
          <a:xfrm>
            <a:off x="2476158" y="2742477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A37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087C89BF-7C5B-3101-59B0-70D76A577596}"/>
              </a:ext>
            </a:extLst>
          </p:cNvPr>
          <p:cNvSpPr txBox="1"/>
          <p:nvPr/>
        </p:nvSpPr>
        <p:spPr bwMode="auto">
          <a:xfrm>
            <a:off x="-1624" y="-18673"/>
            <a:ext cx="295274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defTabSz="594030"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9B8DAF8F-E42B-81BD-45E0-2D721EAA479E}"/>
              </a:ext>
            </a:extLst>
          </p:cNvPr>
          <p:cNvSpPr/>
          <p:nvPr/>
        </p:nvSpPr>
        <p:spPr>
          <a:xfrm>
            <a:off x="4559889" y="6927640"/>
            <a:ext cx="611618" cy="5086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F230EB8-B111-735D-6DA7-035641EF51E4}"/>
              </a:ext>
            </a:extLst>
          </p:cNvPr>
          <p:cNvSpPr txBox="1"/>
          <p:nvPr/>
        </p:nvSpPr>
        <p:spPr>
          <a:xfrm>
            <a:off x="5603012" y="0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S5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25C293B-5497-EEF3-94A6-7F62F2FFF9D9}"/>
              </a:ext>
            </a:extLst>
          </p:cNvPr>
          <p:cNvSpPr txBox="1"/>
          <p:nvPr/>
        </p:nvSpPr>
        <p:spPr>
          <a:xfrm>
            <a:off x="1690985" y="6730694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6F9720FD-9C2E-F2B8-5B30-F5C207B411E5}"/>
              </a:ext>
            </a:extLst>
          </p:cNvPr>
          <p:cNvSpPr/>
          <p:nvPr/>
        </p:nvSpPr>
        <p:spPr>
          <a:xfrm>
            <a:off x="2101303" y="5764959"/>
            <a:ext cx="817510" cy="847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5DF37E0-48FB-B0E2-EDAA-F45B18DF981C}"/>
              </a:ext>
            </a:extLst>
          </p:cNvPr>
          <p:cNvSpPr txBox="1"/>
          <p:nvPr/>
        </p:nvSpPr>
        <p:spPr>
          <a:xfrm>
            <a:off x="1420482" y="5197090"/>
            <a:ext cx="7312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GSDME-NT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99757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文本框 44">
            <a:extLst>
              <a:ext uri="{FF2B5EF4-FFF2-40B4-BE49-F238E27FC236}">
                <a16:creationId xmlns:a16="http://schemas.microsoft.com/office/drawing/2014/main" id="{19E33EAA-BD8E-6D69-9B76-9693E14FF668}"/>
              </a:ext>
            </a:extLst>
          </p:cNvPr>
          <p:cNvSpPr txBox="1"/>
          <p:nvPr/>
        </p:nvSpPr>
        <p:spPr bwMode="auto">
          <a:xfrm>
            <a:off x="857" y="0"/>
            <a:ext cx="295274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defTabSz="594030"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图片 90">
            <a:extLst>
              <a:ext uri="{FF2B5EF4-FFF2-40B4-BE49-F238E27FC236}">
                <a16:creationId xmlns:a16="http://schemas.microsoft.com/office/drawing/2014/main" id="{403EEA86-BABE-334E-5A11-38AD98F629A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74" t="9223" r="9027" b="22429"/>
          <a:stretch/>
        </p:blipFill>
        <p:spPr>
          <a:xfrm>
            <a:off x="411782" y="229593"/>
            <a:ext cx="3651801" cy="24290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2" name="图片 91">
            <a:extLst>
              <a:ext uri="{FF2B5EF4-FFF2-40B4-BE49-F238E27FC236}">
                <a16:creationId xmlns:a16="http://schemas.microsoft.com/office/drawing/2014/main" id="{B9B8426F-A741-8578-8ED8-D37C89801BD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0" t="7483" r="11344" b="13149"/>
          <a:stretch/>
        </p:blipFill>
        <p:spPr>
          <a:xfrm flipH="1">
            <a:off x="411782" y="2850773"/>
            <a:ext cx="3687880" cy="279928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3" name="文本框 92">
            <a:extLst>
              <a:ext uri="{FF2B5EF4-FFF2-40B4-BE49-F238E27FC236}">
                <a16:creationId xmlns:a16="http://schemas.microsoft.com/office/drawing/2014/main" id="{412AB157-119A-153C-49ED-F03856B76013}"/>
              </a:ext>
            </a:extLst>
          </p:cNvPr>
          <p:cNvSpPr txBox="1"/>
          <p:nvPr/>
        </p:nvSpPr>
        <p:spPr>
          <a:xfrm>
            <a:off x="612478" y="512319"/>
            <a:ext cx="647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4-HNE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D5514869-A3FE-48FB-70FC-17F0A69444BF}"/>
              </a:ext>
            </a:extLst>
          </p:cNvPr>
          <p:cNvSpPr txBox="1"/>
          <p:nvPr/>
        </p:nvSpPr>
        <p:spPr>
          <a:xfrm>
            <a:off x="497419" y="3332632"/>
            <a:ext cx="647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53BC6BF-CFA1-C6E9-1380-00CAC65D90A0}"/>
              </a:ext>
            </a:extLst>
          </p:cNvPr>
          <p:cNvSpPr txBox="1"/>
          <p:nvPr/>
        </p:nvSpPr>
        <p:spPr>
          <a:xfrm>
            <a:off x="5603012" y="0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S5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90519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86540EE8-F5D1-D89C-15EF-03339FE15E0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9" t="1333" r="4611" b="5017"/>
          <a:stretch/>
        </p:blipFill>
        <p:spPr>
          <a:xfrm>
            <a:off x="781707" y="2914388"/>
            <a:ext cx="3323265" cy="33834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2427E89D-E5DC-D34E-F2C9-AD05D0321D5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78" t="2787" r="3076" b="4383"/>
          <a:stretch/>
        </p:blipFill>
        <p:spPr>
          <a:xfrm>
            <a:off x="787231" y="605524"/>
            <a:ext cx="3352179" cy="19444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8E2BFE92-AF40-128E-C4B5-EA97E2A3AA7A}"/>
              </a:ext>
            </a:extLst>
          </p:cNvPr>
          <p:cNvSpPr txBox="1"/>
          <p:nvPr/>
        </p:nvSpPr>
        <p:spPr>
          <a:xfrm>
            <a:off x="781706" y="3002763"/>
            <a:ext cx="4363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5D76C3A-B160-A416-26AE-BD12ED10ECB9}"/>
              </a:ext>
            </a:extLst>
          </p:cNvPr>
          <p:cNvSpPr txBox="1"/>
          <p:nvPr/>
        </p:nvSpPr>
        <p:spPr>
          <a:xfrm>
            <a:off x="999875" y="787953"/>
            <a:ext cx="59503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GSDME-NT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7E184A96-20B9-24F4-863E-F9005C7671F1}"/>
              </a:ext>
            </a:extLst>
          </p:cNvPr>
          <p:cNvSpPr txBox="1"/>
          <p:nvPr/>
        </p:nvSpPr>
        <p:spPr bwMode="auto">
          <a:xfrm>
            <a:off x="197749" y="86876"/>
            <a:ext cx="295274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defTabSz="594030"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46DDB20-2592-D9B4-2CA9-B56C00B24036}"/>
              </a:ext>
            </a:extLst>
          </p:cNvPr>
          <p:cNvSpPr txBox="1"/>
          <p:nvPr/>
        </p:nvSpPr>
        <p:spPr>
          <a:xfrm>
            <a:off x="5603012" y="0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S6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C88A88A0-6885-5157-6F41-A4AB7F03A7A5}"/>
              </a:ext>
            </a:extLst>
          </p:cNvPr>
          <p:cNvSpPr/>
          <p:nvPr/>
        </p:nvSpPr>
        <p:spPr>
          <a:xfrm>
            <a:off x="1218044" y="4808170"/>
            <a:ext cx="1210263" cy="10597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1537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2683</TotalTime>
  <Words>74</Words>
  <Application>Microsoft Office PowerPoint</Application>
  <PresentationFormat>自定义</PresentationFormat>
  <Paragraphs>55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3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</dc:creator>
  <cp:lastModifiedBy>Xi Zhao</cp:lastModifiedBy>
  <cp:revision>111</cp:revision>
  <dcterms:created xsi:type="dcterms:W3CDTF">2023-03-02T12:19:46Z</dcterms:created>
  <dcterms:modified xsi:type="dcterms:W3CDTF">2024-01-26T04:29:09Z</dcterms:modified>
</cp:coreProperties>
</file>